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B2B47E-E437-4CF7-8308-430C658FD6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9CBD2-C8A6-47C9-8AAA-485D45DB58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063E29-ADD1-40E1-A03F-E4C004B35BF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DAF4D-FA53-4216-A64D-66E2774603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C5773E-0C0B-4F7A-A759-62BBED84F7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44F072-B77E-49CA-87F5-F4DC98118F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E53A3-9D86-46B8-A97D-26127786A9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FADE5-F9C3-47D9-8053-95B0837D75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620AC6-DE67-459E-B6E2-A5476F4346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A24684-297B-4AA5-B6E2-15A60148AA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4AC48-5C5E-4C4D-AC61-47BE13A86A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4A9C3-08E3-4E78-AB09-63548FBBE4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7B7D34-6DC4-48F9-995D-8940DE2D7D2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rrelations between waist circumference and activation status of blood CD4+ and CD8+  T-Lymphocyte populations a) – d)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earson’s (R) correlation coefficients and significance (p-values) shown, n=30.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F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denotes mean fluorescence intensity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hart 4" descr=""/>
          <p:cNvPicPr/>
          <p:nvPr/>
        </p:nvPicPr>
        <p:blipFill>
          <a:blip r:embed="rId1"/>
          <a:stretch/>
        </p:blipFill>
        <p:spPr>
          <a:xfrm>
            <a:off x="3422520" y="2662200"/>
            <a:ext cx="2675160" cy="2481480"/>
          </a:xfrm>
          <a:prstGeom prst="rect">
            <a:avLst/>
          </a:prstGeom>
          <a:ln w="0">
            <a:noFill/>
          </a:ln>
        </p:spPr>
      </p:pic>
      <p:pic>
        <p:nvPicPr>
          <p:cNvPr id="43" name="Chart 5" descr=""/>
          <p:cNvPicPr/>
          <p:nvPr/>
        </p:nvPicPr>
        <p:blipFill>
          <a:blip r:embed="rId2"/>
          <a:stretch/>
        </p:blipFill>
        <p:spPr>
          <a:xfrm>
            <a:off x="614520" y="2662200"/>
            <a:ext cx="2549520" cy="2476440"/>
          </a:xfrm>
          <a:prstGeom prst="rect">
            <a:avLst/>
          </a:prstGeom>
          <a:ln w="0">
            <a:noFill/>
          </a:ln>
        </p:spPr>
      </p:pic>
      <p:pic>
        <p:nvPicPr>
          <p:cNvPr id="44" name="Chart 6" descr=""/>
          <p:cNvPicPr/>
          <p:nvPr/>
        </p:nvPicPr>
        <p:blipFill>
          <a:blip r:embed="rId3"/>
          <a:stretch/>
        </p:blipFill>
        <p:spPr>
          <a:xfrm>
            <a:off x="3422520" y="5330880"/>
            <a:ext cx="2694240" cy="2336760"/>
          </a:xfrm>
          <a:prstGeom prst="rect">
            <a:avLst/>
          </a:prstGeom>
          <a:ln w="0">
            <a:noFill/>
          </a:ln>
        </p:spPr>
      </p:pic>
      <p:pic>
        <p:nvPicPr>
          <p:cNvPr id="45" name="Chart 7" descr=""/>
          <p:cNvPicPr/>
          <p:nvPr/>
        </p:nvPicPr>
        <p:blipFill>
          <a:blip r:embed="rId4"/>
          <a:stretch/>
        </p:blipFill>
        <p:spPr>
          <a:xfrm>
            <a:off x="614520" y="5330880"/>
            <a:ext cx="2549520" cy="2336760"/>
          </a:xfrm>
          <a:prstGeom prst="rect">
            <a:avLst/>
          </a:prstGeom>
          <a:ln w="0">
            <a:noFill/>
          </a:ln>
        </p:spPr>
      </p:pic>
      <p:sp>
        <p:nvSpPr>
          <p:cNvPr id="46" name="TextBox 8"/>
          <p:cNvSpPr/>
          <p:nvPr/>
        </p:nvSpPr>
        <p:spPr>
          <a:xfrm>
            <a:off x="1484280" y="271296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R= -0.273, p=0.14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4481640" y="271296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R= -0.032, p=0.8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1484280" y="5416560"/>
            <a:ext cx="129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R= -0.132, p=0.48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4481640" y="537048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R= 0.080, p=0.67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406800" y="271296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3"/>
          <p:cNvSpPr/>
          <p:nvPr/>
        </p:nvSpPr>
        <p:spPr>
          <a:xfrm>
            <a:off x="3260520" y="272088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410040" y="537048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c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3260520" y="5370480"/>
            <a:ext cx="32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d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2"/>
          <p:cNvSpPr/>
          <p:nvPr/>
        </p:nvSpPr>
        <p:spPr>
          <a:xfrm>
            <a:off x="158760" y="7689960"/>
            <a:ext cx="6699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br>
              <a:rPr sz="1800"/>
            </a:b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22T11:13:51Z</dcterms:created>
  <dc:creator>Rebecca Travers</dc:creator>
  <dc:description/>
  <dc:language>en-US</dc:language>
  <cp:lastModifiedBy>ravikumar.n</cp:lastModifiedBy>
  <dcterms:modified xsi:type="dcterms:W3CDTF">2014-12-16T22:39:13Z</dcterms:modified>
  <cp:revision>1</cp:revision>
  <dc:subject/>
  <dc:title>Supplementary figure 3. Correlations between waist circumference and activation status of blood CD4+ and CD8+  T-Lymphocyte populations a) – d). Pearson’s (R) correlation coefficients and significance (p-values) shown, n=30. MFI denotes mean fluorescence intensity.</dc:title>
</cp:coreProperties>
</file>